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FA1031-A1C0-4C8A-9E88-577A5A7F0080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7D37C2-694B-4BA6-893D-F9F4A712D658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387D4A-BBD8-443A-89C7-247904628F1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9B4FAA-4AB7-42A6-A180-88E5DE164C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A83F32-C86F-402D-8100-E6C265E9C17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D0EA94-750C-435E-97A6-33364186A4B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25215-6B05-4663-AEC1-3948FDBEEC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46AE57-83EC-4ED0-A522-B90A9E185F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47B0A6-C841-4F7B-9020-8A78A9E5D5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9B966-E8AB-42D2-B66A-2FC4729779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C86289-85A3-4C71-8073-1679B6497C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F3B4C8-5187-40B5-83CD-E486B87377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3A9432-BDEE-4B02-AA2F-7D67CE2DA7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A16B2F-F70A-4DAC-B962-A52D314234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3B8164-8AD5-427B-B7F5-4598E4E1413D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5"/>
          <p:cNvSpPr/>
          <p:nvPr/>
        </p:nvSpPr>
        <p:spPr>
          <a:xfrm>
            <a:off x="115560" y="-15840"/>
            <a:ext cx="149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Supplementary fig 1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Group 9"/>
          <p:cNvGrpSpPr/>
          <p:nvPr/>
        </p:nvGrpSpPr>
        <p:grpSpPr>
          <a:xfrm>
            <a:off x="47520" y="733320"/>
            <a:ext cx="8991720" cy="5429520"/>
            <a:chOff x="47520" y="733320"/>
            <a:chExt cx="8991720" cy="5429520"/>
          </a:xfrm>
        </p:grpSpPr>
        <p:pic>
          <p:nvPicPr>
            <p:cNvPr id="50" name="WT-Brn-3b -Brn-3a-ZF heart-72hrCombined Stacks.avi" descr=""/>
            <p:cNvPicPr/>
            <p:nvPr/>
          </p:nvPicPr>
          <p:blipFill>
            <a:blip r:embed="rId1"/>
            <a:stretch/>
          </p:blipFill>
          <p:spPr>
            <a:xfrm>
              <a:off x="47520" y="3781440"/>
              <a:ext cx="8991720" cy="228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ZF-Brn-3a-3b MO-48 hr - good-Combined Stacks.avi" descr=""/>
            <p:cNvPicPr/>
            <p:nvPr/>
          </p:nvPicPr>
          <p:blipFill>
            <a:blip r:embed="rId2"/>
            <a:stretch/>
          </p:blipFill>
          <p:spPr>
            <a:xfrm>
              <a:off x="866520" y="762480"/>
              <a:ext cx="6743880" cy="2571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TextBox 3"/>
            <p:cNvSpPr/>
            <p:nvPr/>
          </p:nvSpPr>
          <p:spPr>
            <a:xfrm>
              <a:off x="1051200" y="761760"/>
              <a:ext cx="942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ontrol MO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4"/>
            <p:cNvSpPr/>
            <p:nvPr/>
          </p:nvSpPr>
          <p:spPr>
            <a:xfrm>
              <a:off x="4213800" y="3095640"/>
              <a:ext cx="1834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Brn-3a-Brn-3b double MO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tangle 6"/>
            <p:cNvSpPr/>
            <p:nvPr/>
          </p:nvSpPr>
          <p:spPr>
            <a:xfrm>
              <a:off x="6200640" y="3772080"/>
              <a:ext cx="56880" cy="23907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7"/>
            <p:cNvSpPr/>
            <p:nvPr/>
          </p:nvSpPr>
          <p:spPr>
            <a:xfrm>
              <a:off x="3076560" y="3772080"/>
              <a:ext cx="56880" cy="23907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Rectangle 8"/>
            <p:cNvSpPr/>
            <p:nvPr/>
          </p:nvSpPr>
          <p:spPr>
            <a:xfrm flipH="1">
              <a:off x="4163400" y="733320"/>
              <a:ext cx="45720" cy="26290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7" name="TextBox 10"/>
          <p:cNvSpPr/>
          <p:nvPr/>
        </p:nvSpPr>
        <p:spPr>
          <a:xfrm>
            <a:off x="395280" y="260280"/>
            <a:ext cx="8209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Video showing heart function in zebrafish embryos targeted with morpholino oligonucleotides to reduce Brn-3a and Brn-3b compared with non specific control or single morphants targeted for only Brn-3a or Brn-3b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8" name=""/>
          <p:cNvGraphicFramePr/>
          <p:nvPr/>
        </p:nvGraphicFramePr>
        <p:xfrm>
          <a:off x="1547640" y="1125360"/>
          <a:ext cx="3783240" cy="1764000"/>
        </p:xfrm>
        <a:graphic>
          <a:graphicData uri="http://schemas.openxmlformats.org/drawingml/2006/table">
            <a:tbl>
              <a:tblPr/>
              <a:tblGrid>
                <a:gridCol w="408600"/>
                <a:gridCol w="586080"/>
                <a:gridCol w="554040"/>
                <a:gridCol w="423000"/>
                <a:gridCol w="54720"/>
                <a:gridCol w="628920"/>
                <a:gridCol w="554040"/>
                <a:gridCol w="573840"/>
              </a:tblGrid>
              <a:tr h="3445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PD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2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T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TB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a KO GAPD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AKO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2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aKO-ACTB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.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.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.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.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.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.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.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6.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6.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.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.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.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.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.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.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.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9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.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28404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.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.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.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.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.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.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</a:tbl>
          </a:graphicData>
        </a:graphic>
      </p:graphicFrame>
      <p:sp>
        <p:nvSpPr>
          <p:cNvPr id="59" name="Rectangle 3"/>
          <p:cNvSpPr/>
          <p:nvPr/>
        </p:nvSpPr>
        <p:spPr>
          <a:xfrm>
            <a:off x="179280" y="189000"/>
            <a:ext cx="85694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Supplementary Figure 2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Data showing values for quantitative RT-PCR of three different housekeeping genes in cDNA from WT and Brn-3a KO hearts used for quantifying changes in the expression of different gen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2-28T12:37:46Z</dcterms:created>
  <dc:creator>Shanie Budhram-Mahadeo</dc:creator>
  <dc:description/>
  <dc:language>en-US</dc:language>
  <cp:lastModifiedBy>shanmugam.s</cp:lastModifiedBy>
  <dcterms:modified xsi:type="dcterms:W3CDTF">2017-06-02T16:09:08Z</dcterms:modified>
  <cp:revision>7</cp:revision>
  <dc:subject/>
  <dc:title>PowerPoint Presentation</dc:title>
</cp:coreProperties>
</file>